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</p:sldMasterIdLst>
  <p:notesMasterIdLst>
    <p:notesMasterId r:id="rId4"/>
  </p:notesMasterIdLst>
  <p:sldIdLst>
    <p:sldId id="645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4" d="100"/>
          <a:sy n="64" d="100"/>
        </p:scale>
        <p:origin x="1292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rams.adp.vcu.edu\mcc\massey\Labs\Sebti\KaziA2\Sebti%20lab%20data\Documents\Kazi%20Lab%20Expt%20Folder,%203.17.20\AK%20Expt%23%20131,%2004.06.21\Densitometry%20analysis%20results,%2012.13.2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rams.adp.vcu.edu\mcc\massey\Labs\Sebti\KaziA2\Sebti%20lab%20data\Documents\Kazi%20Lab%20Expt%20Folder,%203.17.20\AK%20Expt%23%20131,%2004.06.21\Densitometry%20analysis%20results,%2012.13.2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rams.adp.vcu.edu\mcc\massey\Labs\Sebti\KaziA2\Sebti%20lab%20data\Documents\Kazi%20Lab%20Expt%20Folder,%203.17.20\AK%20Expt%23%20131,%2004.06.21\pErk%20raw%20and%20processed%20old%20densitometry%20for%20Panc1%20and%20Panc02.03,%2001.18.23%20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9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Mek/Mek</a:t>
            </a:r>
          </a:p>
        </c:rich>
      </c:tx>
      <c:layout>
        <c:manualLayout>
          <c:xMode val="edge"/>
          <c:yMode val="edge"/>
          <c:x val="0.56731916475851363"/>
          <c:y val="4.108299664789092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8818678915135609"/>
          <c:y val="9.1195013715155607E-2"/>
          <c:w val="0.6152723097112861"/>
          <c:h val="0.66066720862613271"/>
        </c:manualLayout>
      </c:layout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'Panc1(Time course)(Line graph)'!$H$20:$H$29</c:f>
              <c:strCache>
                <c:ptCount val="10"/>
                <c:pt idx="0">
                  <c:v>0</c:v>
                </c:pt>
                <c:pt idx="1">
                  <c:v>5m</c:v>
                </c:pt>
                <c:pt idx="2">
                  <c:v>15m</c:v>
                </c:pt>
                <c:pt idx="3">
                  <c:v>30m</c:v>
                </c:pt>
                <c:pt idx="4">
                  <c:v>1h</c:v>
                </c:pt>
                <c:pt idx="5">
                  <c:v>2h</c:v>
                </c:pt>
                <c:pt idx="6">
                  <c:v>4h</c:v>
                </c:pt>
                <c:pt idx="7">
                  <c:v>8h</c:v>
                </c:pt>
                <c:pt idx="8">
                  <c:v>24h</c:v>
                </c:pt>
                <c:pt idx="9">
                  <c:v>48h</c:v>
                </c:pt>
              </c:strCache>
            </c:strRef>
          </c:cat>
          <c:val>
            <c:numRef>
              <c:f>'Panc1(Time course)(Line graph)'!$I$20:$I$29</c:f>
              <c:numCache>
                <c:formatCode>0</c:formatCode>
                <c:ptCount val="10"/>
                <c:pt idx="0">
                  <c:v>100</c:v>
                </c:pt>
                <c:pt idx="1">
                  <c:v>397.59563862943548</c:v>
                </c:pt>
                <c:pt idx="2">
                  <c:v>395.32019151224534</c:v>
                </c:pt>
                <c:pt idx="3">
                  <c:v>245.63797639369537</c:v>
                </c:pt>
                <c:pt idx="4">
                  <c:v>140.42241891572559</c:v>
                </c:pt>
                <c:pt idx="5">
                  <c:v>155.50519380873763</c:v>
                </c:pt>
                <c:pt idx="6">
                  <c:v>116.87038718747193</c:v>
                </c:pt>
                <c:pt idx="7">
                  <c:v>85.774965690682308</c:v>
                </c:pt>
                <c:pt idx="8">
                  <c:v>27.383555962087215</c:v>
                </c:pt>
                <c:pt idx="9">
                  <c:v>42.63678754657341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26F4-402E-B456-C6FDCCC69FA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91418656"/>
        <c:axId val="1925886912"/>
      </c:lineChart>
      <c:catAx>
        <c:axId val="20914186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25886912"/>
        <c:crosses val="autoZero"/>
        <c:auto val="1"/>
        <c:lblAlgn val="ctr"/>
        <c:lblOffset val="100"/>
        <c:tickLblSkip val="2"/>
        <c:tickMarkSkip val="2"/>
        <c:noMultiLvlLbl val="0"/>
      </c:catAx>
      <c:valAx>
        <c:axId val="1925886912"/>
        <c:scaling>
          <c:orientation val="minMax"/>
          <c:max val="4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900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% Change</a:t>
                </a:r>
              </a:p>
            </c:rich>
          </c:tx>
          <c:layout>
            <c:manualLayout>
              <c:xMode val="edge"/>
              <c:yMode val="edge"/>
              <c:x val="1.2478127734033254E-3"/>
              <c:y val="5.124015748031496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91418656"/>
        <c:crossesAt val="1"/>
        <c:crossBetween val="midCat"/>
        <c:majorUnit val="100"/>
        <c:minorUnit val="5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900" b="1" i="0" u="none" strike="noStrike" kern="1200" spc="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 sz="9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Mek/Mek</a:t>
            </a:r>
          </a:p>
        </c:rich>
      </c:tx>
      <c:layout>
        <c:manualLayout>
          <c:xMode val="edge"/>
          <c:yMode val="edge"/>
          <c:x val="0.55678121715493278"/>
          <c:y val="0.12484394506866417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1" i="0" u="none" strike="noStrike" kern="1200" spc="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30640079462559677"/>
          <c:y val="7.2143595512450226E-2"/>
          <c:w val="0.60879205063699182"/>
          <c:h val="0.67031664123067614"/>
        </c:manualLayout>
      </c:layout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'Panc02.03(Time course)(Line gr)'!$H$20:$H$29</c:f>
              <c:strCache>
                <c:ptCount val="10"/>
                <c:pt idx="0">
                  <c:v>0</c:v>
                </c:pt>
                <c:pt idx="1">
                  <c:v>5m</c:v>
                </c:pt>
                <c:pt idx="2">
                  <c:v>15m</c:v>
                </c:pt>
                <c:pt idx="3">
                  <c:v>30m</c:v>
                </c:pt>
                <c:pt idx="4">
                  <c:v>1h</c:v>
                </c:pt>
                <c:pt idx="5">
                  <c:v>2h</c:v>
                </c:pt>
                <c:pt idx="6">
                  <c:v>4h</c:v>
                </c:pt>
                <c:pt idx="7">
                  <c:v>8h</c:v>
                </c:pt>
                <c:pt idx="8">
                  <c:v>24h</c:v>
                </c:pt>
                <c:pt idx="9">
                  <c:v>48h</c:v>
                </c:pt>
              </c:strCache>
            </c:strRef>
          </c:cat>
          <c:val>
            <c:numRef>
              <c:f>'Panc02.03(Time course)(Line gr)'!$I$20:$I$29</c:f>
              <c:numCache>
                <c:formatCode>0</c:formatCode>
                <c:ptCount val="10"/>
                <c:pt idx="0">
                  <c:v>100</c:v>
                </c:pt>
                <c:pt idx="1">
                  <c:v>142.63601794566998</c:v>
                </c:pt>
                <c:pt idx="2">
                  <c:v>258.30073595500323</c:v>
                </c:pt>
                <c:pt idx="3">
                  <c:v>167.56883681642563</c:v>
                </c:pt>
                <c:pt idx="4">
                  <c:v>99.345019903681248</c:v>
                </c:pt>
                <c:pt idx="5">
                  <c:v>65.893543637551957</c:v>
                </c:pt>
                <c:pt idx="6">
                  <c:v>67.421018455788285</c:v>
                </c:pt>
                <c:pt idx="7">
                  <c:v>20.342613495887122</c:v>
                </c:pt>
                <c:pt idx="8">
                  <c:v>11.701823144537409</c:v>
                </c:pt>
                <c:pt idx="9">
                  <c:v>9.181495282273695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ED6-40BE-BA70-2D6B72271DE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41088064"/>
        <c:axId val="2084861328"/>
      </c:lineChart>
      <c:catAx>
        <c:axId val="20410880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84861328"/>
        <c:crosses val="autoZero"/>
        <c:auto val="1"/>
        <c:lblAlgn val="ctr"/>
        <c:lblOffset val="100"/>
        <c:tickLblSkip val="2"/>
        <c:tickMarkSkip val="2"/>
        <c:noMultiLvlLbl val="0"/>
      </c:catAx>
      <c:valAx>
        <c:axId val="208486132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900" b="1">
                    <a:solidFill>
                      <a:schemeClr val="tx1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% Change</a:t>
                </a:r>
              </a:p>
            </c:rich>
          </c:tx>
          <c:layout>
            <c:manualLayout>
              <c:xMode val="edge"/>
              <c:yMode val="edge"/>
              <c:x val="2.1317401298316697E-2"/>
              <c:y val="8.4899387576552937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0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041088064"/>
        <c:crossesAt val="1"/>
        <c:crossBetween val="midCat"/>
        <c:majorUnit val="1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0247866099788911"/>
          <c:y val="5.4682519553340692E-2"/>
          <c:w val="0.61257373214745947"/>
          <c:h val="0.7605409814714531"/>
        </c:manualLayout>
      </c:layout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'Raw Old existing pErk '!$B$5:$B$14</c:f>
              <c:strCache>
                <c:ptCount val="10"/>
                <c:pt idx="0">
                  <c:v>0</c:v>
                </c:pt>
                <c:pt idx="1">
                  <c:v>5m</c:v>
                </c:pt>
                <c:pt idx="2">
                  <c:v>15m</c:v>
                </c:pt>
                <c:pt idx="3">
                  <c:v>30m</c:v>
                </c:pt>
                <c:pt idx="4">
                  <c:v>1h</c:v>
                </c:pt>
                <c:pt idx="5">
                  <c:v>2h</c:v>
                </c:pt>
                <c:pt idx="6">
                  <c:v>4h</c:v>
                </c:pt>
                <c:pt idx="7">
                  <c:v>8h</c:v>
                </c:pt>
                <c:pt idx="8">
                  <c:v>24h</c:v>
                </c:pt>
                <c:pt idx="9">
                  <c:v>48h</c:v>
                </c:pt>
              </c:strCache>
            </c:strRef>
          </c:cat>
          <c:val>
            <c:numRef>
              <c:f>'Raw Old existing pErk '!$G$5:$G$14</c:f>
              <c:numCache>
                <c:formatCode>0</c:formatCode>
                <c:ptCount val="10"/>
                <c:pt idx="0" formatCode="General">
                  <c:v>100</c:v>
                </c:pt>
                <c:pt idx="1">
                  <c:v>1434.147746514157</c:v>
                </c:pt>
                <c:pt idx="2">
                  <c:v>1604.1996589136475</c:v>
                </c:pt>
                <c:pt idx="3">
                  <c:v>1061.1371222233511</c:v>
                </c:pt>
                <c:pt idx="4">
                  <c:v>1210.4852776350592</c:v>
                </c:pt>
                <c:pt idx="5">
                  <c:v>699.90615774277808</c:v>
                </c:pt>
                <c:pt idx="6">
                  <c:v>438.14473393550077</c:v>
                </c:pt>
                <c:pt idx="7">
                  <c:v>386.7124979887235</c:v>
                </c:pt>
                <c:pt idx="8">
                  <c:v>125.36744113020409</c:v>
                </c:pt>
                <c:pt idx="9">
                  <c:v>129.584088513576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D5A-4463-B34B-2BAA9D6567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51954255"/>
        <c:axId val="1662311631"/>
      </c:lineChart>
      <c:catAx>
        <c:axId val="1951954255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662311631"/>
        <c:crosses val="autoZero"/>
        <c:auto val="1"/>
        <c:lblAlgn val="ctr"/>
        <c:lblOffset val="100"/>
        <c:tickLblSkip val="2"/>
        <c:tickMarkSkip val="2"/>
        <c:noMultiLvlLbl val="0"/>
      </c:catAx>
      <c:valAx>
        <c:axId val="1662311631"/>
        <c:scaling>
          <c:orientation val="minMax"/>
          <c:max val="165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900" b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% Change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51954255"/>
        <c:crosses val="autoZero"/>
        <c:crossBetween val="midCat"/>
        <c:majorUnit val="5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32567927404994107"/>
          <c:y val="4.7863247863247867E-2"/>
          <c:w val="0.56588466271633742"/>
          <c:h val="0.77897408977723936"/>
        </c:manualLayout>
      </c:layout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'Raw Old existing pErk '!$N$5:$N$14</c:f>
              <c:strCache>
                <c:ptCount val="10"/>
                <c:pt idx="0">
                  <c:v>0</c:v>
                </c:pt>
                <c:pt idx="1">
                  <c:v>5m</c:v>
                </c:pt>
                <c:pt idx="2">
                  <c:v>15m</c:v>
                </c:pt>
                <c:pt idx="3">
                  <c:v>30m</c:v>
                </c:pt>
                <c:pt idx="4">
                  <c:v>1h</c:v>
                </c:pt>
                <c:pt idx="5">
                  <c:v>2h</c:v>
                </c:pt>
                <c:pt idx="6">
                  <c:v>4h</c:v>
                </c:pt>
                <c:pt idx="7">
                  <c:v>8h</c:v>
                </c:pt>
                <c:pt idx="8">
                  <c:v>24h</c:v>
                </c:pt>
                <c:pt idx="9">
                  <c:v>48h</c:v>
                </c:pt>
              </c:strCache>
            </c:strRef>
          </c:cat>
          <c:val>
            <c:numRef>
              <c:f>'Raw Old existing pErk '!$S$5:$S$14</c:f>
              <c:numCache>
                <c:formatCode>0</c:formatCode>
                <c:ptCount val="10"/>
                <c:pt idx="0" formatCode="General">
                  <c:v>100</c:v>
                </c:pt>
                <c:pt idx="1">
                  <c:v>413.52723514667645</c:v>
                </c:pt>
                <c:pt idx="2">
                  <c:v>1415.6684539083483</c:v>
                </c:pt>
                <c:pt idx="3">
                  <c:v>652.76927723322467</c:v>
                </c:pt>
                <c:pt idx="4">
                  <c:v>449.29896651521364</c:v>
                </c:pt>
                <c:pt idx="5">
                  <c:v>293.90171891292078</c:v>
                </c:pt>
                <c:pt idx="6">
                  <c:v>852.89763970972922</c:v>
                </c:pt>
                <c:pt idx="7">
                  <c:v>161.05923556699759</c:v>
                </c:pt>
                <c:pt idx="8">
                  <c:v>198.27107202674785</c:v>
                </c:pt>
                <c:pt idx="9">
                  <c:v>246.240654640216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2A1-456D-B4D5-34538991347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964898959"/>
        <c:axId val="1952075791"/>
      </c:lineChart>
      <c:catAx>
        <c:axId val="1964898959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52075791"/>
        <c:crosses val="autoZero"/>
        <c:auto val="1"/>
        <c:lblAlgn val="ctr"/>
        <c:lblOffset val="100"/>
        <c:tickLblSkip val="2"/>
        <c:tickMarkSkip val="2"/>
        <c:noMultiLvlLbl val="0"/>
      </c:catAx>
      <c:valAx>
        <c:axId val="1952075791"/>
        <c:scaling>
          <c:orientation val="minMax"/>
          <c:max val="15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9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900" b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% Change</a:t>
                </a:r>
              </a:p>
            </c:rich>
          </c:tx>
          <c:layout>
            <c:manualLayout>
              <c:xMode val="edge"/>
              <c:yMode val="edge"/>
              <c:x val="2.1879068346121806E-2"/>
              <c:y val="4.6290463692038493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900" b="1" i="0" u="none" strike="noStrike" kern="1200" baseline="0">
                  <a:solidFill>
                    <a:sysClr val="windowText" lastClr="000000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964898959"/>
        <c:crosses val="autoZero"/>
        <c:crossBetween val="midCat"/>
        <c:majorUnit val="500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wmf"/><Relationship Id="rId3" Type="http://schemas.openxmlformats.org/officeDocument/2006/relationships/image" Target="../media/image3.wmf"/><Relationship Id="rId7" Type="http://schemas.openxmlformats.org/officeDocument/2006/relationships/image" Target="../media/image7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10" Type="http://schemas.openxmlformats.org/officeDocument/2006/relationships/image" Target="../media/image10.wmf"/><Relationship Id="rId4" Type="http://schemas.openxmlformats.org/officeDocument/2006/relationships/image" Target="../media/image4.wmf"/><Relationship Id="rId9" Type="http://schemas.openxmlformats.org/officeDocument/2006/relationships/image" Target="../media/image9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C6C106B-FA27-4611-BED3-E0C2BC00D81E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F08C0B8-9C15-4EFF-8ED6-BF2634AF647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518162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66612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62994F78-CC85-47BE-8395-9068CB32DD3F}" type="slidenum">
              <a:rPr kumimoji="0" lang="en-US" sz="13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pPr marL="0" marR="0" lvl="0" indent="0" algn="r" defTabSz="966612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0" lang="en-US" sz="13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47201455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0C736-E5A2-4056-B1E5-9160284A0E96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6C0E7-2755-4B55-9B5C-1146938E9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95644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0C736-E5A2-4056-B1E5-9160284A0E96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6C0E7-2755-4B55-9B5C-1146938E9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41125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0C736-E5A2-4056-B1E5-9160284A0E96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6C0E7-2755-4B55-9B5C-1146938E9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138878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4CCEB6-B101-42D6-AA14-5889A476F00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29021D6-3FEE-4AA1-ACD4-2592FA57474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BC869E-6439-4B95-971E-08A0F8006B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3E87EF-0317-4734-8169-8F02D57C63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3C7249-8A65-4887-8CEC-1AE20C6080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95583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DE35AC-B878-4B58-87D2-FE2913AB15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B3F5AD-0AA3-4804-90A7-96FE3C5F23A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6566C6-77E6-4D5F-8ADD-EF5960F799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E1AB55-1053-4F13-8942-A4D2098495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999F24-6DB3-4CAD-96C8-1605461B1A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4869037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93631A-2C9B-4DC9-AB1F-553282DC36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040151-9789-419F-AF25-19FA396FE2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9ED2FE-6FFF-4D2F-A4CB-0AD2E0CD86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AB9B5C-5DE4-475F-AD3C-5712D890DD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BC12CD-DB7C-4201-8A78-9FC7A71966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5211576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A2E8EC-93E5-471A-A411-CDB2FDD25D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A3D7A8-6F96-4199-A218-46D291B893D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E8D2094-0FA0-4F72-9DB0-B37A6CD1D5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A38618F-3830-4FFF-AE50-D92E851A99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CE146C-CDF3-43BB-902F-B0394A5A23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9CE579B-8E36-42E4-AAAB-8E0B58D2F4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1023313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66B271-E7A8-4A9E-8580-C3BF08FCA4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B2A9DC9-FBC5-47FF-8AB7-BF826C82A3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93974E5-60A3-44EF-801C-3F8942A02B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39B1D51-8401-4F89-831D-DCFF1BFDB56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DDB4CB3-95C3-4DD2-837C-FF55351C5B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C8C7566-B4C9-475D-8F99-01BEABDF34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9E358CC-A388-435D-A083-3D6F533703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A3E7C51-996E-4A93-9788-D8D7719BA1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66649246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DC0149-A6E5-4EC3-9131-4DAC01AC27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FA2CA2E-4087-4F80-ACF6-5EB9B32D9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F67216F-09A7-4A8F-9EBA-72B2DA93E4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6969AA-AC28-48E9-BDEE-509F65F9E7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7916413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D04223F-3D97-48DF-AA2D-A2AE9A8A69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75A68E9-00B9-46AA-9E84-FB028B6AB1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4679E93-DDE7-4091-9345-833D2933CA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465694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079618-F862-4CC0-ADDB-448D7D1A19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ADB4AB-271D-4F0D-B1A3-7A6D1DC5767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DB7AEBF-E074-4672-900A-B82219FC33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D54FC2-B51B-40D5-9B84-F76AE92EB5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BB546B-1D1A-47A4-A602-D10617AF0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F0584C-6EB2-47B6-AB61-117BDF19AD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877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0C736-E5A2-4056-B1E5-9160284A0E96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6C0E7-2755-4B55-9B5C-1146938E9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38932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D0A5F7-FC8D-46D6-ACBE-B174261E58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5101CE4-7974-4FA4-95FF-6A376EA2535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BC0BED-35F8-40C5-B8EA-CF465636AE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100D1D-1201-4037-A258-5859AB0EF7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6EBD25-CE80-46F7-817D-9003958835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81A877-39E1-4264-B450-53DC0D8BB2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68922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9A941C-77BD-463F-B138-622A78BFBE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B45F6D1-1E9D-4C7C-AF91-D228326A5D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3A022E-1443-4B9E-BDF3-07FF47213F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27B901-6B1A-4878-8039-04AB23C5E9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C8BE28-4A59-4665-8C36-0691DB9BE7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04807457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DA1D671-1406-433A-8810-ED4778BD65B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79FB6AA-DE01-4AC2-90F3-D23EC279D6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05DBEE-99D6-4567-870F-156B03C9B5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F60DAC-CD66-4E2B-9F30-F12CF603B8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0EDD6F-8F0F-4D4C-9C35-D49FC9FEB4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14504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0C736-E5A2-4056-B1E5-9160284A0E96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6C0E7-2755-4B55-9B5C-1146938E9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81308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0C736-E5A2-4056-B1E5-9160284A0E96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6C0E7-2755-4B55-9B5C-1146938E9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21544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0C736-E5A2-4056-B1E5-9160284A0E96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6C0E7-2755-4B55-9B5C-1146938E9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15763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0C736-E5A2-4056-B1E5-9160284A0E96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6C0E7-2755-4B55-9B5C-1146938E9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93102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0C736-E5A2-4056-B1E5-9160284A0E96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6C0E7-2755-4B55-9B5C-1146938E9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40649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0C736-E5A2-4056-B1E5-9160284A0E96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6C0E7-2755-4B55-9B5C-1146938E9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35874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0C736-E5A2-4056-B1E5-9160284A0E96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26C0E7-2755-4B55-9B5C-1146938E9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12514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80C736-E5A2-4056-B1E5-9160284A0E96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26C0E7-2755-4B55-9B5C-1146938E973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1373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D6FC384-0F10-4AAA-B059-B4BFF0F435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3F5C7AD-8811-4B4F-9D46-6AF3601BC4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17AEB5-C7E6-427A-B42F-6B84C374E3D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82CC4A-DFF4-4099-8B8C-0230D015A95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838A4A-6A1C-4788-A47C-715F0365C5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61767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3" Type="http://schemas.openxmlformats.org/officeDocument/2006/relationships/image" Target="../media/image3.wmf"/><Relationship Id="rId18" Type="http://schemas.openxmlformats.org/officeDocument/2006/relationships/oleObject" Target="../embeddings/oleObject6.bin"/><Relationship Id="rId26" Type="http://schemas.openxmlformats.org/officeDocument/2006/relationships/oleObject" Target="../embeddings/oleObject10.bin"/><Relationship Id="rId3" Type="http://schemas.openxmlformats.org/officeDocument/2006/relationships/notesSlide" Target="../notesSlides/notesSlide1.xml"/><Relationship Id="rId21" Type="http://schemas.openxmlformats.org/officeDocument/2006/relationships/image" Target="../media/image7.wmf"/><Relationship Id="rId34" Type="http://schemas.openxmlformats.org/officeDocument/2006/relationships/chart" Target="../charts/chart3.xml"/><Relationship Id="rId7" Type="http://schemas.microsoft.com/office/2007/relationships/hdphoto" Target="../media/hdphoto2.wdp"/><Relationship Id="rId12" Type="http://schemas.openxmlformats.org/officeDocument/2006/relationships/oleObject" Target="../embeddings/oleObject3.bin"/><Relationship Id="rId17" Type="http://schemas.openxmlformats.org/officeDocument/2006/relationships/image" Target="../media/image5.wmf"/><Relationship Id="rId25" Type="http://schemas.openxmlformats.org/officeDocument/2006/relationships/image" Target="../media/image9.wmf"/><Relationship Id="rId33" Type="http://schemas.openxmlformats.org/officeDocument/2006/relationships/chart" Target="../charts/chart2.xml"/><Relationship Id="rId2" Type="http://schemas.openxmlformats.org/officeDocument/2006/relationships/slideLayout" Target="../slideLayouts/slideLayout18.xml"/><Relationship Id="rId16" Type="http://schemas.openxmlformats.org/officeDocument/2006/relationships/oleObject" Target="../embeddings/oleObject5.bin"/><Relationship Id="rId20" Type="http://schemas.openxmlformats.org/officeDocument/2006/relationships/oleObject" Target="../embeddings/oleObject7.bin"/><Relationship Id="rId29" Type="http://schemas.microsoft.com/office/2007/relationships/hdphoto" Target="../media/hdphoto3.wdp"/><Relationship Id="rId1" Type="http://schemas.openxmlformats.org/officeDocument/2006/relationships/vmlDrawing" Target="../drawings/vmlDrawing1.vml"/><Relationship Id="rId6" Type="http://schemas.openxmlformats.org/officeDocument/2006/relationships/image" Target="../media/image12.png"/><Relationship Id="rId11" Type="http://schemas.openxmlformats.org/officeDocument/2006/relationships/image" Target="../media/image2.wmf"/><Relationship Id="rId24" Type="http://schemas.openxmlformats.org/officeDocument/2006/relationships/oleObject" Target="../embeddings/oleObject9.bin"/><Relationship Id="rId32" Type="http://schemas.openxmlformats.org/officeDocument/2006/relationships/chart" Target="../charts/chart1.xml"/><Relationship Id="rId5" Type="http://schemas.microsoft.com/office/2007/relationships/hdphoto" Target="../media/hdphoto1.wdp"/><Relationship Id="rId15" Type="http://schemas.openxmlformats.org/officeDocument/2006/relationships/image" Target="../media/image4.wmf"/><Relationship Id="rId23" Type="http://schemas.openxmlformats.org/officeDocument/2006/relationships/image" Target="../media/image8.wmf"/><Relationship Id="rId28" Type="http://schemas.openxmlformats.org/officeDocument/2006/relationships/image" Target="../media/image13.png"/><Relationship Id="rId10" Type="http://schemas.openxmlformats.org/officeDocument/2006/relationships/oleObject" Target="../embeddings/oleObject2.bin"/><Relationship Id="rId19" Type="http://schemas.openxmlformats.org/officeDocument/2006/relationships/image" Target="../media/image6.wmf"/><Relationship Id="rId31" Type="http://schemas.microsoft.com/office/2007/relationships/hdphoto" Target="../media/hdphoto4.wdp"/><Relationship Id="rId4" Type="http://schemas.openxmlformats.org/officeDocument/2006/relationships/image" Target="../media/image11.png"/><Relationship Id="rId9" Type="http://schemas.openxmlformats.org/officeDocument/2006/relationships/image" Target="../media/image1.wmf"/><Relationship Id="rId14" Type="http://schemas.openxmlformats.org/officeDocument/2006/relationships/oleObject" Target="../embeddings/oleObject4.bin"/><Relationship Id="rId22" Type="http://schemas.openxmlformats.org/officeDocument/2006/relationships/oleObject" Target="../embeddings/oleObject8.bin"/><Relationship Id="rId27" Type="http://schemas.openxmlformats.org/officeDocument/2006/relationships/image" Target="../media/image10.wmf"/><Relationship Id="rId30" Type="http://schemas.openxmlformats.org/officeDocument/2006/relationships/image" Target="../media/image14.png"/><Relationship Id="rId35" Type="http://schemas.openxmlformats.org/officeDocument/2006/relationships/chart" Target="../charts/chart4.xml"/><Relationship Id="rId8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8" name="TextBox 187">
            <a:extLst>
              <a:ext uri="{FF2B5EF4-FFF2-40B4-BE49-F238E27FC236}">
                <a16:creationId xmlns:a16="http://schemas.microsoft.com/office/drawing/2014/main" id="{C4740704-9630-478D-B9E9-01FAFE81D2AA}"/>
              </a:ext>
            </a:extLst>
          </p:cNvPr>
          <p:cNvSpPr txBox="1"/>
          <p:nvPr/>
        </p:nvSpPr>
        <p:spPr>
          <a:xfrm>
            <a:off x="373155" y="1381759"/>
            <a:ext cx="17294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ure S7</a:t>
            </a: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C78AE586-D3EF-48CA-8F8F-5FB36B593E54}"/>
              </a:ext>
            </a:extLst>
          </p:cNvPr>
          <p:cNvGrpSpPr/>
          <p:nvPr/>
        </p:nvGrpSpPr>
        <p:grpSpPr>
          <a:xfrm>
            <a:off x="229876" y="1931205"/>
            <a:ext cx="8684247" cy="2725934"/>
            <a:chOff x="229876" y="549446"/>
            <a:chExt cx="8684247" cy="2725934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4741799B-63AE-4CD0-9D5C-B455779FB6DB}"/>
                </a:ext>
              </a:extLst>
            </p:cNvPr>
            <p:cNvGrpSpPr/>
            <p:nvPr/>
          </p:nvGrpSpPr>
          <p:grpSpPr>
            <a:xfrm>
              <a:off x="229876" y="549446"/>
              <a:ext cx="8684247" cy="2725934"/>
              <a:chOff x="229876" y="549446"/>
              <a:chExt cx="8684247" cy="2725934"/>
            </a:xfrm>
          </p:grpSpPr>
          <p:sp>
            <p:nvSpPr>
              <p:cNvPr id="218" name="TextBox 217">
                <a:extLst>
                  <a:ext uri="{FF2B5EF4-FFF2-40B4-BE49-F238E27FC236}">
                    <a16:creationId xmlns:a16="http://schemas.microsoft.com/office/drawing/2014/main" id="{72F0B988-0B35-4E1D-9B0A-C361D654480F}"/>
                  </a:ext>
                </a:extLst>
              </p:cNvPr>
              <p:cNvSpPr txBox="1"/>
              <p:nvPr/>
            </p:nvSpPr>
            <p:spPr>
              <a:xfrm>
                <a:off x="232479" y="586493"/>
                <a:ext cx="32314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4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a</a:t>
                </a:r>
              </a:p>
            </p:txBody>
          </p:sp>
          <p:sp>
            <p:nvSpPr>
              <p:cNvPr id="158" name="TextBox 157">
                <a:extLst>
                  <a:ext uri="{FF2B5EF4-FFF2-40B4-BE49-F238E27FC236}">
                    <a16:creationId xmlns:a16="http://schemas.microsoft.com/office/drawing/2014/main" id="{5D0733C7-B74E-444C-B9B1-62B4C20089D9}"/>
                  </a:ext>
                </a:extLst>
              </p:cNvPr>
              <p:cNvSpPr txBox="1"/>
              <p:nvPr/>
            </p:nvSpPr>
            <p:spPr>
              <a:xfrm>
                <a:off x="1479202" y="583733"/>
                <a:ext cx="93487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anc0203 </a:t>
                </a:r>
              </a:p>
            </p:txBody>
          </p:sp>
          <p:cxnSp>
            <p:nvCxnSpPr>
              <p:cNvPr id="159" name="Straight Connector 158">
                <a:extLst>
                  <a:ext uri="{FF2B5EF4-FFF2-40B4-BE49-F238E27FC236}">
                    <a16:creationId xmlns:a16="http://schemas.microsoft.com/office/drawing/2014/main" id="{5FDFC68F-6D83-4A24-AF2A-C792309E86C2}"/>
                  </a:ext>
                </a:extLst>
              </p:cNvPr>
              <p:cNvCxnSpPr/>
              <p:nvPr/>
            </p:nvCxnSpPr>
            <p:spPr>
              <a:xfrm>
                <a:off x="971792" y="894270"/>
                <a:ext cx="1853704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9" name="Straight Connector 238">
                <a:extLst>
                  <a:ext uri="{FF2B5EF4-FFF2-40B4-BE49-F238E27FC236}">
                    <a16:creationId xmlns:a16="http://schemas.microsoft.com/office/drawing/2014/main" id="{CF43391A-CEB3-4BE4-8A3C-1338124DC551}"/>
                  </a:ext>
                </a:extLst>
              </p:cNvPr>
              <p:cNvCxnSpPr/>
              <p:nvPr/>
            </p:nvCxnSpPr>
            <p:spPr>
              <a:xfrm>
                <a:off x="3120624" y="894270"/>
                <a:ext cx="1853704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0" name="TextBox 239">
                <a:extLst>
                  <a:ext uri="{FF2B5EF4-FFF2-40B4-BE49-F238E27FC236}">
                    <a16:creationId xmlns:a16="http://schemas.microsoft.com/office/drawing/2014/main" id="{8D928AC2-987A-45B9-A8DE-7E6423AA2D6E}"/>
                  </a:ext>
                </a:extLst>
              </p:cNvPr>
              <p:cNvSpPr txBox="1"/>
              <p:nvPr/>
            </p:nvSpPr>
            <p:spPr>
              <a:xfrm>
                <a:off x="3909638" y="583733"/>
                <a:ext cx="67999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anc1 </a:t>
                </a:r>
              </a:p>
            </p:txBody>
          </p:sp>
          <p:sp>
            <p:nvSpPr>
              <p:cNvPr id="199" name="Rectangle 198">
                <a:extLst>
                  <a:ext uri="{FF2B5EF4-FFF2-40B4-BE49-F238E27FC236}">
                    <a16:creationId xmlns:a16="http://schemas.microsoft.com/office/drawing/2014/main" id="{AC6E9DD4-2139-49BC-A0F5-51B2052A0EF1}"/>
                  </a:ext>
                </a:extLst>
              </p:cNvPr>
              <p:cNvSpPr/>
              <p:nvPr/>
            </p:nvSpPr>
            <p:spPr>
              <a:xfrm>
                <a:off x="246470" y="549446"/>
                <a:ext cx="5086106" cy="2725934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35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200" name="TextBox 199">
                <a:extLst>
                  <a:ext uri="{FF2B5EF4-FFF2-40B4-BE49-F238E27FC236}">
                    <a16:creationId xmlns:a16="http://schemas.microsoft.com/office/drawing/2014/main" id="{D1B4CF53-89E0-4E46-BA81-E623D0F69DDE}"/>
                  </a:ext>
                </a:extLst>
              </p:cNvPr>
              <p:cNvSpPr txBox="1"/>
              <p:nvPr/>
            </p:nvSpPr>
            <p:spPr>
              <a:xfrm>
                <a:off x="230240" y="1897718"/>
                <a:ext cx="7095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-</a:t>
                </a:r>
                <a:r>
                  <a:rPr kumimoji="0" lang="en-US" sz="10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Erk</a:t>
                </a:r>
                <a:r>
                  <a:rPr kumimoji="0" lang="en-US" sz="1000" b="1" i="1" u="none" strike="noStrike" kern="1200" cap="none" spc="0" normalizeH="0" baseline="30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 c</a:t>
                </a:r>
                <a:endParaRPr kumimoji="0" 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202" name="TextBox 201">
                <a:extLst>
                  <a:ext uri="{FF2B5EF4-FFF2-40B4-BE49-F238E27FC236}">
                    <a16:creationId xmlns:a16="http://schemas.microsoft.com/office/drawing/2014/main" id="{334593FA-68D8-4DD4-B389-6A9E54564F12}"/>
                  </a:ext>
                </a:extLst>
              </p:cNvPr>
              <p:cNvSpPr txBox="1"/>
              <p:nvPr/>
            </p:nvSpPr>
            <p:spPr>
              <a:xfrm>
                <a:off x="242933" y="2161599"/>
                <a:ext cx="47801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Erk</a:t>
                </a:r>
                <a:r>
                  <a:rPr kumimoji="0" 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 </a:t>
                </a:r>
                <a:r>
                  <a:rPr kumimoji="0" lang="en-US" sz="1000" b="1" i="1" u="none" strike="noStrike" kern="1200" cap="none" spc="0" normalizeH="0" baseline="30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b</a:t>
                </a:r>
                <a:endParaRPr kumimoji="0" 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206" name="TextBox 205">
                <a:extLst>
                  <a:ext uri="{FF2B5EF4-FFF2-40B4-BE49-F238E27FC236}">
                    <a16:creationId xmlns:a16="http://schemas.microsoft.com/office/drawing/2014/main" id="{315570DF-F995-4723-9FB9-47EE50B7DAB4}"/>
                  </a:ext>
                </a:extLst>
              </p:cNvPr>
              <p:cNvSpPr txBox="1"/>
              <p:nvPr/>
            </p:nvSpPr>
            <p:spPr>
              <a:xfrm>
                <a:off x="229876" y="2681566"/>
                <a:ext cx="7095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l-GR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β</a:t>
                </a:r>
                <a:r>
                  <a:rPr kumimoji="0" 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-Actin</a:t>
                </a:r>
                <a:r>
                  <a:rPr kumimoji="0" lang="en-US" sz="1000" b="1" i="1" u="none" strike="noStrike" kern="1200" cap="none" spc="0" normalizeH="0" baseline="30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 b</a:t>
                </a:r>
                <a:endParaRPr kumimoji="0" 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207" name="TextBox 206">
                <a:extLst>
                  <a:ext uri="{FF2B5EF4-FFF2-40B4-BE49-F238E27FC236}">
                    <a16:creationId xmlns:a16="http://schemas.microsoft.com/office/drawing/2014/main" id="{3899C21C-6309-49F6-8C22-9821C6F15C11}"/>
                  </a:ext>
                </a:extLst>
              </p:cNvPr>
              <p:cNvSpPr txBox="1"/>
              <p:nvPr/>
            </p:nvSpPr>
            <p:spPr>
              <a:xfrm>
                <a:off x="233505" y="2917772"/>
                <a:ext cx="731677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l-GR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β</a:t>
                </a:r>
                <a:r>
                  <a:rPr kumimoji="0" 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-Actin</a:t>
                </a:r>
                <a:r>
                  <a:rPr kumimoji="0" lang="en-US" sz="1000" b="1" i="1" u="none" strike="noStrike" kern="1200" cap="none" spc="0" normalizeH="0" baseline="30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 c</a:t>
                </a:r>
                <a:endParaRPr kumimoji="0" 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212" name="TextBox 211">
                <a:extLst>
                  <a:ext uri="{FF2B5EF4-FFF2-40B4-BE49-F238E27FC236}">
                    <a16:creationId xmlns:a16="http://schemas.microsoft.com/office/drawing/2014/main" id="{F639CC77-3B11-4991-B598-8603B242163E}"/>
                  </a:ext>
                </a:extLst>
              </p:cNvPr>
              <p:cNvSpPr txBox="1"/>
              <p:nvPr/>
            </p:nvSpPr>
            <p:spPr>
              <a:xfrm>
                <a:off x="233505" y="2430470"/>
                <a:ext cx="709551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l-GR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β</a:t>
                </a:r>
                <a:r>
                  <a:rPr kumimoji="0" 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-Actin </a:t>
                </a:r>
                <a:r>
                  <a:rPr kumimoji="0" lang="en-US" sz="1000" b="1" i="1" u="none" strike="noStrike" kern="1200" cap="none" spc="0" normalizeH="0" baseline="30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a</a:t>
                </a:r>
                <a:endParaRPr kumimoji="0" 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283" name="TextBox 282">
                <a:extLst>
                  <a:ext uri="{FF2B5EF4-FFF2-40B4-BE49-F238E27FC236}">
                    <a16:creationId xmlns:a16="http://schemas.microsoft.com/office/drawing/2014/main" id="{9335924F-98E6-4795-8B92-1C3EA4C60A1B}"/>
                  </a:ext>
                </a:extLst>
              </p:cNvPr>
              <p:cNvSpPr txBox="1"/>
              <p:nvPr/>
            </p:nvSpPr>
            <p:spPr>
              <a:xfrm>
                <a:off x="234818" y="1436128"/>
                <a:ext cx="63831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-</a:t>
                </a:r>
                <a:r>
                  <a:rPr kumimoji="0" lang="en-US" sz="10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Mek</a:t>
                </a:r>
                <a:r>
                  <a:rPr kumimoji="0" lang="en-US" sz="10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 </a:t>
                </a:r>
                <a:r>
                  <a:rPr kumimoji="0" lang="en-US" sz="1000" b="1" i="1" u="none" strike="noStrike" kern="1200" cap="none" spc="0" normalizeH="0" baseline="3000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a</a:t>
                </a:r>
                <a:endParaRPr kumimoji="0" lang="en-US" sz="1000" b="1" i="0" u="none" strike="noStrike" kern="1200" cap="none" spc="0" normalizeH="0" baseline="3000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320" name="TextBox 319">
                <a:extLst>
                  <a:ext uri="{FF2B5EF4-FFF2-40B4-BE49-F238E27FC236}">
                    <a16:creationId xmlns:a16="http://schemas.microsoft.com/office/drawing/2014/main" id="{EC90A872-F6DD-4F0B-9CE1-D8FD33CE3C2C}"/>
                  </a:ext>
                </a:extLst>
              </p:cNvPr>
              <p:cNvSpPr txBox="1"/>
              <p:nvPr/>
            </p:nvSpPr>
            <p:spPr>
              <a:xfrm>
                <a:off x="246470" y="1673526"/>
                <a:ext cx="431475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0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Mek</a:t>
                </a:r>
                <a:endParaRPr kumimoji="0" lang="en-US" sz="10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grpSp>
            <p:nvGrpSpPr>
              <p:cNvPr id="9" name="Group 8">
                <a:extLst>
                  <a:ext uri="{FF2B5EF4-FFF2-40B4-BE49-F238E27FC236}">
                    <a16:creationId xmlns:a16="http://schemas.microsoft.com/office/drawing/2014/main" id="{C54E7960-07E2-4A53-978B-F00CC217E8FA}"/>
                  </a:ext>
                </a:extLst>
              </p:cNvPr>
              <p:cNvGrpSpPr/>
              <p:nvPr/>
            </p:nvGrpSpPr>
            <p:grpSpPr>
              <a:xfrm>
                <a:off x="973808" y="817460"/>
                <a:ext cx="2085481" cy="681516"/>
                <a:chOff x="4147241" y="3307707"/>
                <a:chExt cx="2085481" cy="681516"/>
              </a:xfrm>
            </p:grpSpPr>
            <p:grpSp>
              <p:nvGrpSpPr>
                <p:cNvPr id="198" name="Group 197">
                  <a:extLst>
                    <a:ext uri="{FF2B5EF4-FFF2-40B4-BE49-F238E27FC236}">
                      <a16:creationId xmlns:a16="http://schemas.microsoft.com/office/drawing/2014/main" id="{B4868B04-14D6-4693-8F4F-7252F3C17ACC}"/>
                    </a:ext>
                  </a:extLst>
                </p:cNvPr>
                <p:cNvGrpSpPr/>
                <p:nvPr/>
              </p:nvGrpSpPr>
              <p:grpSpPr>
                <a:xfrm>
                  <a:off x="4147241" y="3307707"/>
                  <a:ext cx="1876362" cy="681516"/>
                  <a:chOff x="6397092" y="1517848"/>
                  <a:chExt cx="1998542" cy="725893"/>
                </a:xfrm>
              </p:grpSpPr>
              <p:sp>
                <p:nvSpPr>
                  <p:cNvPr id="353" name="TextBox 352">
                    <a:extLst>
                      <a:ext uri="{FF2B5EF4-FFF2-40B4-BE49-F238E27FC236}">
                        <a16:creationId xmlns:a16="http://schemas.microsoft.com/office/drawing/2014/main" id="{5E3BE1AA-F485-48DB-A543-8C8E780425E6}"/>
                      </a:ext>
                    </a:extLst>
                  </p:cNvPr>
                  <p:cNvSpPr txBox="1"/>
                  <p:nvPr/>
                </p:nvSpPr>
                <p:spPr>
                  <a:xfrm rot="17975979">
                    <a:off x="6214743" y="1771475"/>
                    <a:ext cx="626951" cy="26225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6858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0 min  </a:t>
                    </a:r>
                  </a:p>
                </p:txBody>
              </p:sp>
              <p:sp>
                <p:nvSpPr>
                  <p:cNvPr id="354" name="TextBox 353">
                    <a:extLst>
                      <a:ext uri="{FF2B5EF4-FFF2-40B4-BE49-F238E27FC236}">
                        <a16:creationId xmlns:a16="http://schemas.microsoft.com/office/drawing/2014/main" id="{130F0CF9-958B-47EA-A156-F452A3FC8C27}"/>
                      </a:ext>
                    </a:extLst>
                  </p:cNvPr>
                  <p:cNvSpPr txBox="1"/>
                  <p:nvPr/>
                </p:nvSpPr>
                <p:spPr>
                  <a:xfrm rot="17975979">
                    <a:off x="6446332" y="1768555"/>
                    <a:ext cx="626951" cy="26225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6858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5 min  </a:t>
                    </a:r>
                  </a:p>
                </p:txBody>
              </p:sp>
              <p:sp>
                <p:nvSpPr>
                  <p:cNvPr id="355" name="TextBox 354">
                    <a:extLst>
                      <a:ext uri="{FF2B5EF4-FFF2-40B4-BE49-F238E27FC236}">
                        <a16:creationId xmlns:a16="http://schemas.microsoft.com/office/drawing/2014/main" id="{1FBD941D-83D9-43BC-9F96-B460389444C7}"/>
                      </a:ext>
                    </a:extLst>
                  </p:cNvPr>
                  <p:cNvSpPr txBox="1"/>
                  <p:nvPr/>
                </p:nvSpPr>
                <p:spPr>
                  <a:xfrm rot="17975979">
                    <a:off x="6647224" y="1761576"/>
                    <a:ext cx="702076" cy="2622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6858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15 min  </a:t>
                    </a:r>
                  </a:p>
                </p:txBody>
              </p:sp>
              <p:sp>
                <p:nvSpPr>
                  <p:cNvPr id="356" name="TextBox 355">
                    <a:extLst>
                      <a:ext uri="{FF2B5EF4-FFF2-40B4-BE49-F238E27FC236}">
                        <a16:creationId xmlns:a16="http://schemas.microsoft.com/office/drawing/2014/main" id="{58716319-92DE-4205-BE6A-94F338CAF2D1}"/>
                      </a:ext>
                    </a:extLst>
                  </p:cNvPr>
                  <p:cNvSpPr txBox="1"/>
                  <p:nvPr/>
                </p:nvSpPr>
                <p:spPr>
                  <a:xfrm rot="17975979">
                    <a:off x="6850629" y="1737759"/>
                    <a:ext cx="702076" cy="2622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6858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30 min  </a:t>
                    </a:r>
                  </a:p>
                </p:txBody>
              </p:sp>
              <p:sp>
                <p:nvSpPr>
                  <p:cNvPr id="357" name="TextBox 356">
                    <a:extLst>
                      <a:ext uri="{FF2B5EF4-FFF2-40B4-BE49-F238E27FC236}">
                        <a16:creationId xmlns:a16="http://schemas.microsoft.com/office/drawing/2014/main" id="{D19162C4-C484-4070-9399-F35CD58FF4EF}"/>
                      </a:ext>
                    </a:extLst>
                  </p:cNvPr>
                  <p:cNvSpPr txBox="1"/>
                  <p:nvPr/>
                </p:nvSpPr>
                <p:spPr>
                  <a:xfrm rot="17975979">
                    <a:off x="7117332" y="1844992"/>
                    <a:ext cx="468165" cy="2622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6858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1 h  </a:t>
                    </a:r>
                  </a:p>
                </p:txBody>
              </p:sp>
              <p:sp>
                <p:nvSpPr>
                  <p:cNvPr id="358" name="TextBox 357">
                    <a:extLst>
                      <a:ext uri="{FF2B5EF4-FFF2-40B4-BE49-F238E27FC236}">
                        <a16:creationId xmlns:a16="http://schemas.microsoft.com/office/drawing/2014/main" id="{458EC217-5FCB-4B81-962F-C5987BEAFF8C}"/>
                      </a:ext>
                    </a:extLst>
                  </p:cNvPr>
                  <p:cNvSpPr txBox="1"/>
                  <p:nvPr/>
                </p:nvSpPr>
                <p:spPr>
                  <a:xfrm rot="17975979">
                    <a:off x="7339200" y="1821334"/>
                    <a:ext cx="468165" cy="2622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6858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2 h  </a:t>
                    </a:r>
                  </a:p>
                </p:txBody>
              </p:sp>
              <p:sp>
                <p:nvSpPr>
                  <p:cNvPr id="359" name="TextBox 358">
                    <a:extLst>
                      <a:ext uri="{FF2B5EF4-FFF2-40B4-BE49-F238E27FC236}">
                        <a16:creationId xmlns:a16="http://schemas.microsoft.com/office/drawing/2014/main" id="{40BDA4F4-76CA-4035-A50B-4CA728092117}"/>
                      </a:ext>
                    </a:extLst>
                  </p:cNvPr>
                  <p:cNvSpPr txBox="1"/>
                  <p:nvPr/>
                </p:nvSpPr>
                <p:spPr>
                  <a:xfrm rot="17975979">
                    <a:off x="7551245" y="1826254"/>
                    <a:ext cx="468165" cy="2622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6858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4 h  </a:t>
                    </a:r>
                  </a:p>
                </p:txBody>
              </p:sp>
              <p:sp>
                <p:nvSpPr>
                  <p:cNvPr id="360" name="TextBox 359">
                    <a:extLst>
                      <a:ext uri="{FF2B5EF4-FFF2-40B4-BE49-F238E27FC236}">
                        <a16:creationId xmlns:a16="http://schemas.microsoft.com/office/drawing/2014/main" id="{3108EFF0-DE9E-49A6-9545-E278C263CEB7}"/>
                      </a:ext>
                    </a:extLst>
                  </p:cNvPr>
                  <p:cNvSpPr txBox="1"/>
                  <p:nvPr/>
                </p:nvSpPr>
                <p:spPr>
                  <a:xfrm rot="17975979">
                    <a:off x="7777596" y="1825947"/>
                    <a:ext cx="468165" cy="2622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6858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8 h  </a:t>
                    </a:r>
                  </a:p>
                </p:txBody>
              </p:sp>
              <p:sp>
                <p:nvSpPr>
                  <p:cNvPr id="361" name="TextBox 360">
                    <a:extLst>
                      <a:ext uri="{FF2B5EF4-FFF2-40B4-BE49-F238E27FC236}">
                        <a16:creationId xmlns:a16="http://schemas.microsoft.com/office/drawing/2014/main" id="{6407DC7E-C68B-4B37-8499-BFEA3264C0C5}"/>
                      </a:ext>
                    </a:extLst>
                  </p:cNvPr>
                  <p:cNvSpPr txBox="1"/>
                  <p:nvPr/>
                </p:nvSpPr>
                <p:spPr>
                  <a:xfrm rot="17975979">
                    <a:off x="7992862" y="1786620"/>
                    <a:ext cx="543290" cy="2622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6858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24 h  </a:t>
                    </a:r>
                  </a:p>
                </p:txBody>
              </p:sp>
            </p:grpSp>
            <p:sp>
              <p:nvSpPr>
                <p:cNvPr id="322" name="TextBox 321">
                  <a:extLst>
                    <a:ext uri="{FF2B5EF4-FFF2-40B4-BE49-F238E27FC236}">
                      <a16:creationId xmlns:a16="http://schemas.microsoft.com/office/drawing/2014/main" id="{28BCD64E-0517-42AA-A1C9-62AE0B94BEA8}"/>
                    </a:ext>
                  </a:extLst>
                </p:cNvPr>
                <p:cNvSpPr txBox="1"/>
                <p:nvPr/>
              </p:nvSpPr>
              <p:spPr>
                <a:xfrm rot="17975979">
                  <a:off x="5854574" y="3589932"/>
                  <a:ext cx="51007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6858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48 h  </a:t>
                  </a:r>
                </a:p>
              </p:txBody>
            </p:sp>
          </p:grpSp>
          <p:pic>
            <p:nvPicPr>
              <p:cNvPr id="282" name="Picture 281">
                <a:extLst>
                  <a:ext uri="{FF2B5EF4-FFF2-40B4-BE49-F238E27FC236}">
                    <a16:creationId xmlns:a16="http://schemas.microsoft.com/office/drawing/2014/main" id="{850BA518-AA32-472C-874A-571AAE7C07CF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3066854" y="1455348"/>
                <a:ext cx="2128148" cy="195896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319" name="Picture 318">
                <a:extLst>
                  <a:ext uri="{FF2B5EF4-FFF2-40B4-BE49-F238E27FC236}">
                    <a16:creationId xmlns:a16="http://schemas.microsoft.com/office/drawing/2014/main" id="{014D7652-8518-4882-BE01-97EA128AE48A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889730" y="1454699"/>
                <a:ext cx="2130552" cy="188794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graphicFrame>
            <p:nvGraphicFramePr>
              <p:cNvPr id="324" name="Object 323">
                <a:extLst>
                  <a:ext uri="{FF2B5EF4-FFF2-40B4-BE49-F238E27FC236}">
                    <a16:creationId xmlns:a16="http://schemas.microsoft.com/office/drawing/2014/main" id="{C508D260-2D79-45F8-B01A-A5F48087AA62}"/>
                  </a:ext>
                </a:extLst>
              </p:cNvPr>
              <p:cNvGraphicFramePr>
                <a:graphicFrameLocks/>
              </p:cNvGraphicFramePr>
              <p:nvPr>
                <p:extLst/>
              </p:nvPr>
            </p:nvGraphicFramePr>
            <p:xfrm>
              <a:off x="889730" y="1934470"/>
              <a:ext cx="2130639" cy="21879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26" r:id="rId8" imgW="2054160" imgH="210240" progId="">
                      <p:embed/>
                    </p:oleObj>
                  </mc:Choice>
                  <mc:Fallback>
                    <p:oleObj r:id="rId8" imgW="2054160" imgH="210240" progId="">
                      <p:embed/>
                      <p:pic>
                        <p:nvPicPr>
                          <p:cNvPr id="324" name="Object 323">
                            <a:extLst>
                              <a:ext uri="{FF2B5EF4-FFF2-40B4-BE49-F238E27FC236}">
                                <a16:creationId xmlns:a16="http://schemas.microsoft.com/office/drawing/2014/main" id="{C508D260-2D79-45F8-B01A-A5F48087AA62}"/>
                              </a:ext>
                            </a:extLst>
                          </p:cNvPr>
                          <p:cNvPicPr preferRelativeResize="0"/>
                          <p:nvPr/>
                        </p:nvPicPr>
                        <p:blipFill>
                          <a:blip r:embed="rId9">
                            <a:lum contrast="-20000"/>
                          </a:blip>
                          <a:stretch>
                            <a:fillRect/>
                          </a:stretch>
                        </p:blipFill>
                        <p:spPr>
                          <a:xfrm>
                            <a:off x="889730" y="1934470"/>
                            <a:ext cx="2130639" cy="218793"/>
                          </a:xfrm>
                          <a:prstGeom prst="rect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325" name="Object 324">
                <a:extLst>
                  <a:ext uri="{FF2B5EF4-FFF2-40B4-BE49-F238E27FC236}">
                    <a16:creationId xmlns:a16="http://schemas.microsoft.com/office/drawing/2014/main" id="{55FF9DD0-8E12-4430-A683-4013DD260EDE}"/>
                  </a:ext>
                </a:extLst>
              </p:cNvPr>
              <p:cNvGraphicFramePr>
                <a:graphicFrameLocks/>
              </p:cNvGraphicFramePr>
              <p:nvPr>
                <p:extLst/>
              </p:nvPr>
            </p:nvGraphicFramePr>
            <p:xfrm>
              <a:off x="3066854" y="1945526"/>
              <a:ext cx="2130552" cy="21951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27" r:id="rId10" imgW="2017440" imgH="207000" progId="">
                      <p:embed/>
                    </p:oleObj>
                  </mc:Choice>
                  <mc:Fallback>
                    <p:oleObj r:id="rId10" imgW="2017440" imgH="207000" progId="">
                      <p:embed/>
                      <p:pic>
                        <p:nvPicPr>
                          <p:cNvPr id="325" name="Object 324">
                            <a:extLst>
                              <a:ext uri="{FF2B5EF4-FFF2-40B4-BE49-F238E27FC236}">
                                <a16:creationId xmlns:a16="http://schemas.microsoft.com/office/drawing/2014/main" id="{55FF9DD0-8E12-4430-A683-4013DD260EDE}"/>
                              </a:ext>
                            </a:extLst>
                          </p:cNvPr>
                          <p:cNvPicPr preferRelativeResize="0"/>
                          <p:nvPr/>
                        </p:nvPicPr>
                        <p:blipFill>
                          <a:blip r:embed="rId11">
                            <a:lum contrast="-20000"/>
                          </a:blip>
                          <a:stretch>
                            <a:fillRect/>
                          </a:stretch>
                        </p:blipFill>
                        <p:spPr>
                          <a:xfrm>
                            <a:off x="3066854" y="1945526"/>
                            <a:ext cx="2130552" cy="219518"/>
                          </a:xfrm>
                          <a:prstGeom prst="rect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326" name="Object 325">
                <a:extLst>
                  <a:ext uri="{FF2B5EF4-FFF2-40B4-BE49-F238E27FC236}">
                    <a16:creationId xmlns:a16="http://schemas.microsoft.com/office/drawing/2014/main" id="{8911B5B4-A4BE-48E7-AA39-7C13615D3095}"/>
                  </a:ext>
                </a:extLst>
              </p:cNvPr>
              <p:cNvGraphicFramePr>
                <a:graphicFrameLocks/>
              </p:cNvGraphicFramePr>
              <p:nvPr>
                <p:extLst/>
              </p:nvPr>
            </p:nvGraphicFramePr>
            <p:xfrm>
              <a:off x="889730" y="2180535"/>
              <a:ext cx="2127245" cy="233281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28" r:id="rId12" imgW="2054160" imgH="228600" progId="">
                      <p:embed/>
                    </p:oleObj>
                  </mc:Choice>
                  <mc:Fallback>
                    <p:oleObj r:id="rId12" imgW="2054160" imgH="228600" progId="">
                      <p:embed/>
                      <p:pic>
                        <p:nvPicPr>
                          <p:cNvPr id="326" name="Object 325">
                            <a:extLst>
                              <a:ext uri="{FF2B5EF4-FFF2-40B4-BE49-F238E27FC236}">
                                <a16:creationId xmlns:a16="http://schemas.microsoft.com/office/drawing/2014/main" id="{8911B5B4-A4BE-48E7-AA39-7C13615D3095}"/>
                              </a:ext>
                            </a:extLst>
                          </p:cNvPr>
                          <p:cNvPicPr preferRelativeResize="0"/>
                          <p:nvPr/>
                        </p:nvPicPr>
                        <p:blipFill>
                          <a:blip r:embed="rId13">
                            <a:lum contrast="-20000"/>
                          </a:blip>
                          <a:stretch>
                            <a:fillRect/>
                          </a:stretch>
                        </p:blipFill>
                        <p:spPr>
                          <a:xfrm>
                            <a:off x="889730" y="2180535"/>
                            <a:ext cx="2127245" cy="233281"/>
                          </a:xfrm>
                          <a:prstGeom prst="rect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327" name="Object 326">
                <a:extLst>
                  <a:ext uri="{FF2B5EF4-FFF2-40B4-BE49-F238E27FC236}">
                    <a16:creationId xmlns:a16="http://schemas.microsoft.com/office/drawing/2014/main" id="{595D1453-66C9-4E86-9297-564F0C707D3E}"/>
                  </a:ext>
                </a:extLst>
              </p:cNvPr>
              <p:cNvGraphicFramePr>
                <a:graphicFrameLocks/>
              </p:cNvGraphicFramePr>
              <p:nvPr>
                <p:extLst/>
              </p:nvPr>
            </p:nvGraphicFramePr>
            <p:xfrm>
              <a:off x="3066854" y="2191215"/>
              <a:ext cx="2130552" cy="21532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29" r:id="rId14" imgW="2078640" imgH="243720" progId="">
                      <p:embed/>
                    </p:oleObj>
                  </mc:Choice>
                  <mc:Fallback>
                    <p:oleObj r:id="rId14" imgW="2078640" imgH="243720" progId="">
                      <p:embed/>
                      <p:pic>
                        <p:nvPicPr>
                          <p:cNvPr id="327" name="Object 326">
                            <a:extLst>
                              <a:ext uri="{FF2B5EF4-FFF2-40B4-BE49-F238E27FC236}">
                                <a16:creationId xmlns:a16="http://schemas.microsoft.com/office/drawing/2014/main" id="{595D1453-66C9-4E86-9297-564F0C707D3E}"/>
                              </a:ext>
                            </a:extLst>
                          </p:cNvPr>
                          <p:cNvPicPr preferRelativeResize="0"/>
                          <p:nvPr/>
                        </p:nvPicPr>
                        <p:blipFill>
                          <a:blip r:embed="rId15">
                            <a:lum contrast="-20000"/>
                          </a:blip>
                          <a:stretch>
                            <a:fillRect/>
                          </a:stretch>
                        </p:blipFill>
                        <p:spPr>
                          <a:xfrm>
                            <a:off x="3066854" y="2191215"/>
                            <a:ext cx="2130552" cy="215325"/>
                          </a:xfrm>
                          <a:prstGeom prst="rect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336" name="Object 335">
                <a:extLst>
                  <a:ext uri="{FF2B5EF4-FFF2-40B4-BE49-F238E27FC236}">
                    <a16:creationId xmlns:a16="http://schemas.microsoft.com/office/drawing/2014/main" id="{D6CFF7FA-3C47-49FF-918C-08B391B3697B}"/>
                  </a:ext>
                </a:extLst>
              </p:cNvPr>
              <p:cNvGraphicFramePr>
                <a:graphicFrameLocks/>
              </p:cNvGraphicFramePr>
              <p:nvPr>
                <p:extLst/>
              </p:nvPr>
            </p:nvGraphicFramePr>
            <p:xfrm>
              <a:off x="889730" y="2471166"/>
              <a:ext cx="2130552" cy="19323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30" r:id="rId16" imgW="2099880" imgH="219240" progId="">
                      <p:embed/>
                    </p:oleObj>
                  </mc:Choice>
                  <mc:Fallback>
                    <p:oleObj r:id="rId16" imgW="2099880" imgH="219240" progId="">
                      <p:embed/>
                      <p:pic>
                        <p:nvPicPr>
                          <p:cNvPr id="336" name="Object 335">
                            <a:extLst>
                              <a:ext uri="{FF2B5EF4-FFF2-40B4-BE49-F238E27FC236}">
                                <a16:creationId xmlns:a16="http://schemas.microsoft.com/office/drawing/2014/main" id="{D6CFF7FA-3C47-49FF-918C-08B391B3697B}"/>
                              </a:ext>
                            </a:extLst>
                          </p:cNvPr>
                          <p:cNvPicPr preferRelativeResize="0"/>
                          <p:nvPr/>
                        </p:nvPicPr>
                        <p:blipFill>
                          <a:blip r:embed="rId17">
                            <a:lum bright="-20000" contrast="20000"/>
                          </a:blip>
                          <a:stretch>
                            <a:fillRect/>
                          </a:stretch>
                        </p:blipFill>
                        <p:spPr>
                          <a:xfrm>
                            <a:off x="889730" y="2471166"/>
                            <a:ext cx="2130552" cy="193238"/>
                          </a:xfrm>
                          <a:prstGeom prst="rect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337" name="Object 336">
                <a:extLst>
                  <a:ext uri="{FF2B5EF4-FFF2-40B4-BE49-F238E27FC236}">
                    <a16:creationId xmlns:a16="http://schemas.microsoft.com/office/drawing/2014/main" id="{13957E82-CFDC-4171-A35A-DD25CF500022}"/>
                  </a:ext>
                </a:extLst>
              </p:cNvPr>
              <p:cNvGraphicFramePr>
                <a:graphicFrameLocks/>
              </p:cNvGraphicFramePr>
              <p:nvPr>
                <p:extLst/>
              </p:nvPr>
            </p:nvGraphicFramePr>
            <p:xfrm>
              <a:off x="889730" y="2719660"/>
              <a:ext cx="2130552" cy="219518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31" r:id="rId18" imgW="2097000" imgH="225360" progId="">
                      <p:embed/>
                    </p:oleObj>
                  </mc:Choice>
                  <mc:Fallback>
                    <p:oleObj r:id="rId18" imgW="2097000" imgH="225360" progId="">
                      <p:embed/>
                      <p:pic>
                        <p:nvPicPr>
                          <p:cNvPr id="337" name="Object 336">
                            <a:extLst>
                              <a:ext uri="{FF2B5EF4-FFF2-40B4-BE49-F238E27FC236}">
                                <a16:creationId xmlns:a16="http://schemas.microsoft.com/office/drawing/2014/main" id="{13957E82-CFDC-4171-A35A-DD25CF500022}"/>
                              </a:ext>
                            </a:extLst>
                          </p:cNvPr>
                          <p:cNvPicPr preferRelativeResize="0"/>
                          <p:nvPr/>
                        </p:nvPicPr>
                        <p:blipFill>
                          <a:blip r:embed="rId19">
                            <a:lum contrast="-20000"/>
                          </a:blip>
                          <a:stretch>
                            <a:fillRect/>
                          </a:stretch>
                        </p:blipFill>
                        <p:spPr>
                          <a:xfrm>
                            <a:off x="889730" y="2719660"/>
                            <a:ext cx="2130552" cy="219518"/>
                          </a:xfrm>
                          <a:prstGeom prst="rect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338" name="Object 337">
                <a:extLst>
                  <a:ext uri="{FF2B5EF4-FFF2-40B4-BE49-F238E27FC236}">
                    <a16:creationId xmlns:a16="http://schemas.microsoft.com/office/drawing/2014/main" id="{15B74F65-3A87-4B82-9FFC-5E03D3A91919}"/>
                  </a:ext>
                </a:extLst>
              </p:cNvPr>
              <p:cNvGraphicFramePr>
                <a:graphicFrameLocks/>
              </p:cNvGraphicFramePr>
              <p:nvPr>
                <p:extLst/>
              </p:nvPr>
            </p:nvGraphicFramePr>
            <p:xfrm>
              <a:off x="889730" y="2976790"/>
              <a:ext cx="2130552" cy="204127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32" r:id="rId20" imgW="2063160" imgH="198000" progId="">
                      <p:embed/>
                    </p:oleObj>
                  </mc:Choice>
                  <mc:Fallback>
                    <p:oleObj r:id="rId20" imgW="2063160" imgH="198000" progId="">
                      <p:embed/>
                      <p:pic>
                        <p:nvPicPr>
                          <p:cNvPr id="338" name="Object 337">
                            <a:extLst>
                              <a:ext uri="{FF2B5EF4-FFF2-40B4-BE49-F238E27FC236}">
                                <a16:creationId xmlns:a16="http://schemas.microsoft.com/office/drawing/2014/main" id="{15B74F65-3A87-4B82-9FFC-5E03D3A91919}"/>
                              </a:ext>
                            </a:extLst>
                          </p:cNvPr>
                          <p:cNvPicPr preferRelativeResize="0"/>
                          <p:nvPr/>
                        </p:nvPicPr>
                        <p:blipFill>
                          <a:blip r:embed="rId21">
                            <a:lum contrast="-20000"/>
                          </a:blip>
                          <a:stretch>
                            <a:fillRect/>
                          </a:stretch>
                        </p:blipFill>
                        <p:spPr>
                          <a:xfrm>
                            <a:off x="889730" y="2976790"/>
                            <a:ext cx="2130552" cy="204127"/>
                          </a:xfrm>
                          <a:prstGeom prst="rect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339" name="Object 338">
                <a:extLst>
                  <a:ext uri="{FF2B5EF4-FFF2-40B4-BE49-F238E27FC236}">
                    <a16:creationId xmlns:a16="http://schemas.microsoft.com/office/drawing/2014/main" id="{F2DECACD-53E0-49EA-BBE1-105FA8B6BA9F}"/>
                  </a:ext>
                </a:extLst>
              </p:cNvPr>
              <p:cNvGraphicFramePr>
                <a:graphicFrameLocks/>
              </p:cNvGraphicFramePr>
              <p:nvPr>
                <p:extLst/>
              </p:nvPr>
            </p:nvGraphicFramePr>
            <p:xfrm>
              <a:off x="3066854" y="2719660"/>
              <a:ext cx="2130640" cy="210243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33" r:id="rId22" imgW="2090880" imgH="216360" progId="">
                      <p:embed/>
                    </p:oleObj>
                  </mc:Choice>
                  <mc:Fallback>
                    <p:oleObj r:id="rId22" imgW="2090880" imgH="216360" progId="">
                      <p:embed/>
                      <p:pic>
                        <p:nvPicPr>
                          <p:cNvPr id="339" name="Object 338">
                            <a:extLst>
                              <a:ext uri="{FF2B5EF4-FFF2-40B4-BE49-F238E27FC236}">
                                <a16:creationId xmlns:a16="http://schemas.microsoft.com/office/drawing/2014/main" id="{F2DECACD-53E0-49EA-BBE1-105FA8B6BA9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23">
                            <a:lum contrast="-20000"/>
                          </a:blip>
                          <a:stretch>
                            <a:fillRect/>
                          </a:stretch>
                        </p:blipFill>
                        <p:spPr>
                          <a:xfrm>
                            <a:off x="3066854" y="2719660"/>
                            <a:ext cx="2130640" cy="210243"/>
                          </a:xfrm>
                          <a:prstGeom prst="rect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340" name="Object 339">
                <a:extLst>
                  <a:ext uri="{FF2B5EF4-FFF2-40B4-BE49-F238E27FC236}">
                    <a16:creationId xmlns:a16="http://schemas.microsoft.com/office/drawing/2014/main" id="{0F112EF0-F3F1-4545-B3A8-B3D22A221BFF}"/>
                  </a:ext>
                </a:extLst>
              </p:cNvPr>
              <p:cNvGraphicFramePr>
                <a:graphicFrameLocks/>
              </p:cNvGraphicFramePr>
              <p:nvPr>
                <p:extLst/>
              </p:nvPr>
            </p:nvGraphicFramePr>
            <p:xfrm>
              <a:off x="3066854" y="2471166"/>
              <a:ext cx="2130552" cy="196716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34" r:id="rId24" imgW="2072520" imgH="210240" progId="">
                      <p:embed/>
                    </p:oleObj>
                  </mc:Choice>
                  <mc:Fallback>
                    <p:oleObj r:id="rId24" imgW="2072520" imgH="210240" progId="">
                      <p:embed/>
                      <p:pic>
                        <p:nvPicPr>
                          <p:cNvPr id="340" name="Object 339">
                            <a:extLst>
                              <a:ext uri="{FF2B5EF4-FFF2-40B4-BE49-F238E27FC236}">
                                <a16:creationId xmlns:a16="http://schemas.microsoft.com/office/drawing/2014/main" id="{0F112EF0-F3F1-4545-B3A8-B3D22A221BFF}"/>
                              </a:ext>
                            </a:extLst>
                          </p:cNvPr>
                          <p:cNvPicPr preferRelativeResize="0"/>
                          <p:nvPr/>
                        </p:nvPicPr>
                        <p:blipFill>
                          <a:blip r:embed="rId25">
                            <a:lum contrast="-20000"/>
                          </a:blip>
                          <a:stretch>
                            <a:fillRect/>
                          </a:stretch>
                        </p:blipFill>
                        <p:spPr>
                          <a:xfrm>
                            <a:off x="3066854" y="2471166"/>
                            <a:ext cx="2130552" cy="196716"/>
                          </a:xfrm>
                          <a:prstGeom prst="rect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341" name="Object 340">
                <a:extLst>
                  <a:ext uri="{FF2B5EF4-FFF2-40B4-BE49-F238E27FC236}">
                    <a16:creationId xmlns:a16="http://schemas.microsoft.com/office/drawing/2014/main" id="{9C4ACC0B-B960-45E8-BB3D-16E1FC32510B}"/>
                  </a:ext>
                </a:extLst>
              </p:cNvPr>
              <p:cNvGraphicFramePr>
                <a:graphicFrameLocks/>
              </p:cNvGraphicFramePr>
              <p:nvPr>
                <p:extLst/>
              </p:nvPr>
            </p:nvGraphicFramePr>
            <p:xfrm>
              <a:off x="3066854" y="2967583"/>
              <a:ext cx="2130552" cy="213334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35" r:id="rId26" imgW="2063160" imgH="234360" progId="">
                      <p:embed/>
                    </p:oleObj>
                  </mc:Choice>
                  <mc:Fallback>
                    <p:oleObj r:id="rId26" imgW="2063160" imgH="234360" progId="">
                      <p:embed/>
                      <p:pic>
                        <p:nvPicPr>
                          <p:cNvPr id="341" name="Object 340">
                            <a:extLst>
                              <a:ext uri="{FF2B5EF4-FFF2-40B4-BE49-F238E27FC236}">
                                <a16:creationId xmlns:a16="http://schemas.microsoft.com/office/drawing/2014/main" id="{9C4ACC0B-B960-45E8-BB3D-16E1FC32510B}"/>
                              </a:ext>
                            </a:extLst>
                          </p:cNvPr>
                          <p:cNvPicPr preferRelativeResize="0"/>
                          <p:nvPr/>
                        </p:nvPicPr>
                        <p:blipFill>
                          <a:blip r:embed="rId27">
                            <a:lum bright="-20000" contrast="20000"/>
                          </a:blip>
                          <a:stretch>
                            <a:fillRect/>
                          </a:stretch>
                        </p:blipFill>
                        <p:spPr>
                          <a:xfrm>
                            <a:off x="3066854" y="2967583"/>
                            <a:ext cx="2130552" cy="213334"/>
                          </a:xfrm>
                          <a:prstGeom prst="rect">
                            <a:avLst/>
                          </a:prstGeom>
                          <a:ln>
                            <a:solidFill>
                              <a:schemeClr val="tx1"/>
                            </a:solidFill>
                          </a:ln>
                        </p:spPr>
                      </p:pic>
                    </p:oleObj>
                  </mc:Fallback>
                </mc:AlternateContent>
              </a:graphicData>
            </a:graphic>
          </p:graphicFrame>
          <p:pic>
            <p:nvPicPr>
              <p:cNvPr id="195" name="Picture 194">
                <a:extLst>
                  <a:ext uri="{FF2B5EF4-FFF2-40B4-BE49-F238E27FC236}">
                    <a16:creationId xmlns:a16="http://schemas.microsoft.com/office/drawing/2014/main" id="{FD7A0ABF-3E84-4EAE-9A6E-C86050200EBC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28">
                <a:extLst>
                  <a:ext uri="{BEBA8EAE-BF5A-486C-A8C5-ECC9F3942E4B}">
                    <a14:imgProps xmlns:a14="http://schemas.microsoft.com/office/drawing/2010/main">
                      <a14:imgLayer r:embed="rId29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rcRect t="4036" b="5976"/>
              <a:stretch/>
            </p:blipFill>
            <p:spPr>
              <a:xfrm>
                <a:off x="891355" y="1695729"/>
                <a:ext cx="2130552" cy="192024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196" name="Picture 195">
                <a:extLst>
                  <a:ext uri="{FF2B5EF4-FFF2-40B4-BE49-F238E27FC236}">
                    <a16:creationId xmlns:a16="http://schemas.microsoft.com/office/drawing/2014/main" id="{47582193-4265-49F1-A8CE-A0CF84FFB187}"/>
                  </a:ext>
                </a:extLst>
              </p:cNvPr>
              <p:cNvPicPr preferRelativeResize="0">
                <a:picLocks/>
              </p:cNvPicPr>
              <p:nvPr/>
            </p:nvPicPr>
            <p:blipFill rotWithShape="1">
              <a:blip r:embed="rId30">
                <a:extLst>
                  <a:ext uri="{BEBA8EAE-BF5A-486C-A8C5-ECC9F3942E4B}">
                    <a14:imgProps xmlns:a14="http://schemas.microsoft.com/office/drawing/2010/main">
                      <a14:imgLayer r:embed="rId31">
                        <a14:imgEffect>
                          <a14:brightnessContrast bright="-20000" contrast="40000"/>
                        </a14:imgEffect>
                      </a14:imgLayer>
                    </a14:imgProps>
                  </a:ext>
                </a:extLst>
              </a:blip>
              <a:srcRect t="3147" b="1289"/>
              <a:stretch/>
            </p:blipFill>
            <p:spPr>
              <a:xfrm>
                <a:off x="3072355" y="1701724"/>
                <a:ext cx="2130552" cy="192024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grpSp>
            <p:nvGrpSpPr>
              <p:cNvPr id="193" name="Group 192">
                <a:extLst>
                  <a:ext uri="{FF2B5EF4-FFF2-40B4-BE49-F238E27FC236}">
                    <a16:creationId xmlns:a16="http://schemas.microsoft.com/office/drawing/2014/main" id="{8BB6AF35-52CF-4A90-8CE0-52AE20A29699}"/>
                  </a:ext>
                </a:extLst>
              </p:cNvPr>
              <p:cNvGrpSpPr/>
              <p:nvPr/>
            </p:nvGrpSpPr>
            <p:grpSpPr>
              <a:xfrm>
                <a:off x="3161867" y="817460"/>
                <a:ext cx="2085481" cy="681516"/>
                <a:chOff x="4147241" y="3307707"/>
                <a:chExt cx="2085481" cy="681516"/>
              </a:xfrm>
            </p:grpSpPr>
            <p:grpSp>
              <p:nvGrpSpPr>
                <p:cNvPr id="194" name="Group 193">
                  <a:extLst>
                    <a:ext uri="{FF2B5EF4-FFF2-40B4-BE49-F238E27FC236}">
                      <a16:creationId xmlns:a16="http://schemas.microsoft.com/office/drawing/2014/main" id="{9FBBAC6A-830A-44E1-8B97-011A89EAE3DE}"/>
                    </a:ext>
                  </a:extLst>
                </p:cNvPr>
                <p:cNvGrpSpPr/>
                <p:nvPr/>
              </p:nvGrpSpPr>
              <p:grpSpPr>
                <a:xfrm>
                  <a:off x="4147241" y="3307707"/>
                  <a:ext cx="1876362" cy="681516"/>
                  <a:chOff x="6397092" y="1517848"/>
                  <a:chExt cx="1998542" cy="725893"/>
                </a:xfrm>
              </p:grpSpPr>
              <p:sp>
                <p:nvSpPr>
                  <p:cNvPr id="214" name="TextBox 213">
                    <a:extLst>
                      <a:ext uri="{FF2B5EF4-FFF2-40B4-BE49-F238E27FC236}">
                        <a16:creationId xmlns:a16="http://schemas.microsoft.com/office/drawing/2014/main" id="{53CD354D-D29B-4B00-8344-D700093107E2}"/>
                      </a:ext>
                    </a:extLst>
                  </p:cNvPr>
                  <p:cNvSpPr txBox="1"/>
                  <p:nvPr/>
                </p:nvSpPr>
                <p:spPr>
                  <a:xfrm rot="17975979">
                    <a:off x="6214743" y="1771475"/>
                    <a:ext cx="626951" cy="26225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6858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0 min  </a:t>
                    </a:r>
                  </a:p>
                </p:txBody>
              </p:sp>
              <p:sp>
                <p:nvSpPr>
                  <p:cNvPr id="215" name="TextBox 214">
                    <a:extLst>
                      <a:ext uri="{FF2B5EF4-FFF2-40B4-BE49-F238E27FC236}">
                        <a16:creationId xmlns:a16="http://schemas.microsoft.com/office/drawing/2014/main" id="{8D6D1569-580D-4A99-ABEF-131E2757DE2C}"/>
                      </a:ext>
                    </a:extLst>
                  </p:cNvPr>
                  <p:cNvSpPr txBox="1"/>
                  <p:nvPr/>
                </p:nvSpPr>
                <p:spPr>
                  <a:xfrm rot="17975979">
                    <a:off x="6446332" y="1768555"/>
                    <a:ext cx="626951" cy="262253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6858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5 min  </a:t>
                    </a:r>
                  </a:p>
                </p:txBody>
              </p:sp>
              <p:sp>
                <p:nvSpPr>
                  <p:cNvPr id="216" name="TextBox 215">
                    <a:extLst>
                      <a:ext uri="{FF2B5EF4-FFF2-40B4-BE49-F238E27FC236}">
                        <a16:creationId xmlns:a16="http://schemas.microsoft.com/office/drawing/2014/main" id="{F49C674A-EB91-40FD-A77F-8E9407C7CB7E}"/>
                      </a:ext>
                    </a:extLst>
                  </p:cNvPr>
                  <p:cNvSpPr txBox="1"/>
                  <p:nvPr/>
                </p:nvSpPr>
                <p:spPr>
                  <a:xfrm rot="17975979">
                    <a:off x="6647224" y="1761576"/>
                    <a:ext cx="702076" cy="2622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6858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15 min  </a:t>
                    </a:r>
                  </a:p>
                </p:txBody>
              </p:sp>
              <p:sp>
                <p:nvSpPr>
                  <p:cNvPr id="217" name="TextBox 216">
                    <a:extLst>
                      <a:ext uri="{FF2B5EF4-FFF2-40B4-BE49-F238E27FC236}">
                        <a16:creationId xmlns:a16="http://schemas.microsoft.com/office/drawing/2014/main" id="{9D9C4F87-A215-4F8D-8619-18B0BCA56ADD}"/>
                      </a:ext>
                    </a:extLst>
                  </p:cNvPr>
                  <p:cNvSpPr txBox="1"/>
                  <p:nvPr/>
                </p:nvSpPr>
                <p:spPr>
                  <a:xfrm rot="17975979">
                    <a:off x="6850629" y="1737759"/>
                    <a:ext cx="702076" cy="2622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6858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30 min  </a:t>
                    </a:r>
                  </a:p>
                </p:txBody>
              </p:sp>
              <p:sp>
                <p:nvSpPr>
                  <p:cNvPr id="220" name="TextBox 219">
                    <a:extLst>
                      <a:ext uri="{FF2B5EF4-FFF2-40B4-BE49-F238E27FC236}">
                        <a16:creationId xmlns:a16="http://schemas.microsoft.com/office/drawing/2014/main" id="{6F63A49B-4C53-45DF-99FA-18C36B0C97AB}"/>
                      </a:ext>
                    </a:extLst>
                  </p:cNvPr>
                  <p:cNvSpPr txBox="1"/>
                  <p:nvPr/>
                </p:nvSpPr>
                <p:spPr>
                  <a:xfrm rot="17975979">
                    <a:off x="7117332" y="1844992"/>
                    <a:ext cx="468165" cy="2622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6858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1 h  </a:t>
                    </a:r>
                  </a:p>
                </p:txBody>
              </p:sp>
              <p:sp>
                <p:nvSpPr>
                  <p:cNvPr id="221" name="TextBox 220">
                    <a:extLst>
                      <a:ext uri="{FF2B5EF4-FFF2-40B4-BE49-F238E27FC236}">
                        <a16:creationId xmlns:a16="http://schemas.microsoft.com/office/drawing/2014/main" id="{5060ECDB-A2A0-47CA-83E1-B0D0CA76045E}"/>
                      </a:ext>
                    </a:extLst>
                  </p:cNvPr>
                  <p:cNvSpPr txBox="1"/>
                  <p:nvPr/>
                </p:nvSpPr>
                <p:spPr>
                  <a:xfrm rot="17975979">
                    <a:off x="7339200" y="1821334"/>
                    <a:ext cx="468165" cy="2622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6858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2 h  </a:t>
                    </a:r>
                  </a:p>
                </p:txBody>
              </p:sp>
              <p:sp>
                <p:nvSpPr>
                  <p:cNvPr id="222" name="TextBox 221">
                    <a:extLst>
                      <a:ext uri="{FF2B5EF4-FFF2-40B4-BE49-F238E27FC236}">
                        <a16:creationId xmlns:a16="http://schemas.microsoft.com/office/drawing/2014/main" id="{196E749C-8BA1-4247-8A48-3712DE69357E}"/>
                      </a:ext>
                    </a:extLst>
                  </p:cNvPr>
                  <p:cNvSpPr txBox="1"/>
                  <p:nvPr/>
                </p:nvSpPr>
                <p:spPr>
                  <a:xfrm rot="17975979">
                    <a:off x="7551245" y="1826254"/>
                    <a:ext cx="468165" cy="2622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6858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4 h  </a:t>
                    </a:r>
                  </a:p>
                </p:txBody>
              </p:sp>
              <p:sp>
                <p:nvSpPr>
                  <p:cNvPr id="223" name="TextBox 222">
                    <a:extLst>
                      <a:ext uri="{FF2B5EF4-FFF2-40B4-BE49-F238E27FC236}">
                        <a16:creationId xmlns:a16="http://schemas.microsoft.com/office/drawing/2014/main" id="{C281B9DF-6EB1-4BC7-8C36-4747CF12ADA4}"/>
                      </a:ext>
                    </a:extLst>
                  </p:cNvPr>
                  <p:cNvSpPr txBox="1"/>
                  <p:nvPr/>
                </p:nvSpPr>
                <p:spPr>
                  <a:xfrm rot="17975979">
                    <a:off x="7777596" y="1825947"/>
                    <a:ext cx="468165" cy="2622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6858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8 h  </a:t>
                    </a:r>
                  </a:p>
                </p:txBody>
              </p:sp>
              <p:sp>
                <p:nvSpPr>
                  <p:cNvPr id="224" name="TextBox 223">
                    <a:extLst>
                      <a:ext uri="{FF2B5EF4-FFF2-40B4-BE49-F238E27FC236}">
                        <a16:creationId xmlns:a16="http://schemas.microsoft.com/office/drawing/2014/main" id="{76B804CC-EA52-4167-870C-5FC1B8FF7A43}"/>
                      </a:ext>
                    </a:extLst>
                  </p:cNvPr>
                  <p:cNvSpPr txBox="1"/>
                  <p:nvPr/>
                </p:nvSpPr>
                <p:spPr>
                  <a:xfrm rot="17975979">
                    <a:off x="7992862" y="1786620"/>
                    <a:ext cx="543290" cy="26225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marL="0" marR="0" lvl="0" indent="0" algn="l" defTabSz="6858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sz="10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rPr>
                      <a:t>24 h  </a:t>
                    </a:r>
                  </a:p>
                </p:txBody>
              </p:sp>
            </p:grpSp>
            <p:sp>
              <p:nvSpPr>
                <p:cNvPr id="197" name="TextBox 196">
                  <a:extLst>
                    <a:ext uri="{FF2B5EF4-FFF2-40B4-BE49-F238E27FC236}">
                      <a16:creationId xmlns:a16="http://schemas.microsoft.com/office/drawing/2014/main" id="{77379F85-92F6-4D46-998E-7640145A343E}"/>
                    </a:ext>
                  </a:extLst>
                </p:cNvPr>
                <p:cNvSpPr txBox="1"/>
                <p:nvPr/>
              </p:nvSpPr>
              <p:spPr>
                <a:xfrm rot="17975979">
                  <a:off x="5854574" y="3589932"/>
                  <a:ext cx="510076" cy="246221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6858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0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48 h  </a:t>
                  </a:r>
                </a:p>
              </p:txBody>
            </p:sp>
          </p:grpSp>
          <p:sp>
            <p:nvSpPr>
              <p:cNvPr id="160" name="Rectangle 159">
                <a:extLst>
                  <a:ext uri="{FF2B5EF4-FFF2-40B4-BE49-F238E27FC236}">
                    <a16:creationId xmlns:a16="http://schemas.microsoft.com/office/drawing/2014/main" id="{622BE7F6-985C-41F7-AE15-029A2CC9FBC1}"/>
                  </a:ext>
                </a:extLst>
              </p:cNvPr>
              <p:cNvSpPr/>
              <p:nvPr/>
            </p:nvSpPr>
            <p:spPr>
              <a:xfrm>
                <a:off x="5394658" y="549446"/>
                <a:ext cx="3519465" cy="2725934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graphicFrame>
            <p:nvGraphicFramePr>
              <p:cNvPr id="161" name="Chart 160">
                <a:extLst>
                  <a:ext uri="{FF2B5EF4-FFF2-40B4-BE49-F238E27FC236}">
                    <a16:creationId xmlns:a16="http://schemas.microsoft.com/office/drawing/2014/main" id="{2773238D-6E5F-4BD7-BB82-3AABEBD135BE}"/>
                  </a:ext>
                </a:extLst>
              </p:cNvPr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7184885" y="1211049"/>
              <a:ext cx="1699724" cy="81381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2"/>
              </a:graphicData>
            </a:graphic>
          </p:graphicFrame>
          <p:sp>
            <p:nvSpPr>
              <p:cNvPr id="168" name="TextBox 167">
                <a:extLst>
                  <a:ext uri="{FF2B5EF4-FFF2-40B4-BE49-F238E27FC236}">
                    <a16:creationId xmlns:a16="http://schemas.microsoft.com/office/drawing/2014/main" id="{7B8E585A-2D6B-4773-AF42-89E2EF900AF3}"/>
                  </a:ext>
                </a:extLst>
              </p:cNvPr>
              <p:cNvSpPr txBox="1"/>
              <p:nvPr/>
            </p:nvSpPr>
            <p:spPr>
              <a:xfrm>
                <a:off x="7799708" y="577492"/>
                <a:ext cx="63671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anc1</a:t>
                </a:r>
              </a:p>
            </p:txBody>
          </p:sp>
          <p:sp>
            <p:nvSpPr>
              <p:cNvPr id="171" name="TextBox 170">
                <a:extLst>
                  <a:ext uri="{FF2B5EF4-FFF2-40B4-BE49-F238E27FC236}">
                    <a16:creationId xmlns:a16="http://schemas.microsoft.com/office/drawing/2014/main" id="{63014FF5-D2AD-4E08-A454-A98AF6707532}"/>
                  </a:ext>
                </a:extLst>
              </p:cNvPr>
              <p:cNvSpPr txBox="1"/>
              <p:nvPr/>
            </p:nvSpPr>
            <p:spPr>
              <a:xfrm>
                <a:off x="7727369" y="2967738"/>
                <a:ext cx="101181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reatment time</a:t>
                </a:r>
              </a:p>
            </p:txBody>
          </p:sp>
          <p:graphicFrame>
            <p:nvGraphicFramePr>
              <p:cNvPr id="189" name="Chart 188">
                <a:extLst>
                  <a:ext uri="{FF2B5EF4-FFF2-40B4-BE49-F238E27FC236}">
                    <a16:creationId xmlns:a16="http://schemas.microsoft.com/office/drawing/2014/main" id="{BB00C6E7-806B-4586-9020-E61992AB063D}"/>
                  </a:ext>
                </a:extLst>
              </p:cNvPr>
              <p:cNvGraphicFramePr>
                <a:graphicFrameLocks noChangeAspect="1"/>
              </p:cNvGraphicFramePr>
              <p:nvPr>
                <p:extLst/>
              </p:nvPr>
            </p:nvGraphicFramePr>
            <p:xfrm>
              <a:off x="5434801" y="1211049"/>
              <a:ext cx="1704023" cy="81381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3"/>
              </a:graphicData>
            </a:graphic>
          </p:graphicFrame>
          <p:sp>
            <p:nvSpPr>
              <p:cNvPr id="191" name="TextBox 190">
                <a:extLst>
                  <a:ext uri="{FF2B5EF4-FFF2-40B4-BE49-F238E27FC236}">
                    <a16:creationId xmlns:a16="http://schemas.microsoft.com/office/drawing/2014/main" id="{C7D347D1-FA8F-4CFC-9482-15F4C8B34B84}"/>
                  </a:ext>
                </a:extLst>
              </p:cNvPr>
              <p:cNvSpPr txBox="1"/>
              <p:nvPr/>
            </p:nvSpPr>
            <p:spPr>
              <a:xfrm>
                <a:off x="6041700" y="586493"/>
                <a:ext cx="89159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2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anc0203</a:t>
                </a:r>
              </a:p>
            </p:txBody>
          </p:sp>
          <p:sp>
            <p:nvSpPr>
              <p:cNvPr id="247" name="TextBox 246">
                <a:extLst>
                  <a:ext uri="{FF2B5EF4-FFF2-40B4-BE49-F238E27FC236}">
                    <a16:creationId xmlns:a16="http://schemas.microsoft.com/office/drawing/2014/main" id="{CDC68B73-422B-46BA-A840-28F015642A58}"/>
                  </a:ext>
                </a:extLst>
              </p:cNvPr>
              <p:cNvSpPr txBox="1"/>
              <p:nvPr/>
            </p:nvSpPr>
            <p:spPr>
              <a:xfrm>
                <a:off x="5949801" y="2967738"/>
                <a:ext cx="101181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reatment time</a:t>
                </a:r>
              </a:p>
            </p:txBody>
          </p:sp>
          <p:graphicFrame>
            <p:nvGraphicFramePr>
              <p:cNvPr id="156" name="Chart 155">
                <a:extLst>
                  <a:ext uri="{FF2B5EF4-FFF2-40B4-BE49-F238E27FC236}">
                    <a16:creationId xmlns:a16="http://schemas.microsoft.com/office/drawing/2014/main" id="{F27534DA-F376-4C2C-A24C-13A9900760A3}"/>
                  </a:ext>
                </a:extLst>
              </p:cNvPr>
              <p:cNvGraphicFramePr>
                <a:graphicFrameLocks/>
              </p:cNvGraphicFramePr>
              <p:nvPr>
                <p:extLst/>
              </p:nvPr>
            </p:nvGraphicFramePr>
            <p:xfrm>
              <a:off x="7165004" y="2067984"/>
              <a:ext cx="1728216" cy="81381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4"/>
              </a:graphicData>
            </a:graphic>
          </p:graphicFrame>
          <p:graphicFrame>
            <p:nvGraphicFramePr>
              <p:cNvPr id="155" name="Chart 154">
                <a:extLst>
                  <a:ext uri="{FF2B5EF4-FFF2-40B4-BE49-F238E27FC236}">
                    <a16:creationId xmlns:a16="http://schemas.microsoft.com/office/drawing/2014/main" id="{D05B6D88-E6EB-4913-9AB4-EEB8A39136FD}"/>
                  </a:ext>
                </a:extLst>
              </p:cNvPr>
              <p:cNvGraphicFramePr>
                <a:graphicFrameLocks/>
              </p:cNvGraphicFramePr>
              <p:nvPr>
                <p:extLst/>
              </p:nvPr>
            </p:nvGraphicFramePr>
            <p:xfrm>
              <a:off x="5424978" y="2067984"/>
              <a:ext cx="1728216" cy="81381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5"/>
              </a:graphicData>
            </a:graphic>
          </p:graphicFrame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6D86EC73-6E5C-44AF-A7F6-9F5630F2C69E}"/>
                  </a:ext>
                </a:extLst>
              </p:cNvPr>
              <p:cNvSpPr txBox="1"/>
              <p:nvPr/>
            </p:nvSpPr>
            <p:spPr>
              <a:xfrm>
                <a:off x="8177977" y="2163375"/>
                <a:ext cx="65915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Erk</a:t>
                </a:r>
                <a:r>
                  <a:rPr kumimoji="0" lang="en-US" sz="9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/</a:t>
                </a:r>
                <a:r>
                  <a:rPr kumimoji="0" lang="en-US" sz="9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Erk</a:t>
                </a:r>
                <a:endParaRPr kumimoji="0" lang="en-US" sz="9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219" name="TextBox 218">
                <a:extLst>
                  <a:ext uri="{FF2B5EF4-FFF2-40B4-BE49-F238E27FC236}">
                    <a16:creationId xmlns:a16="http://schemas.microsoft.com/office/drawing/2014/main" id="{DE824CFA-0A0B-48BA-A647-E11C2A2569A4}"/>
                  </a:ext>
                </a:extLst>
              </p:cNvPr>
              <p:cNvSpPr txBox="1"/>
              <p:nvPr/>
            </p:nvSpPr>
            <p:spPr>
              <a:xfrm>
                <a:off x="6274136" y="2079176"/>
                <a:ext cx="659155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4572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9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pErk</a:t>
                </a:r>
                <a:r>
                  <a:rPr kumimoji="0" lang="en-US" sz="9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/</a:t>
                </a:r>
                <a:r>
                  <a:rPr kumimoji="0" lang="en-US" sz="900" b="1" i="0" u="none" strike="noStrike" kern="1200" cap="none" spc="0" normalizeH="0" baseline="0" noProof="0" dirty="0" err="1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Erk</a:t>
                </a:r>
                <a:endParaRPr kumimoji="0" lang="en-US" sz="9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192" name="TextBox 191">
                <a:extLst>
                  <a:ext uri="{FF2B5EF4-FFF2-40B4-BE49-F238E27FC236}">
                    <a16:creationId xmlns:a16="http://schemas.microsoft.com/office/drawing/2014/main" id="{390A45EE-3CDE-48EC-9DB2-FEAB65AA8989}"/>
                  </a:ext>
                </a:extLst>
              </p:cNvPr>
              <p:cNvSpPr txBox="1"/>
              <p:nvPr/>
            </p:nvSpPr>
            <p:spPr>
              <a:xfrm>
                <a:off x="5406711" y="549446"/>
                <a:ext cx="32314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4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b</a:t>
                </a:r>
              </a:p>
            </p:txBody>
          </p:sp>
        </p:grpSp>
        <p:cxnSp>
          <p:nvCxnSpPr>
            <p:cNvPr id="87" name="Straight Connector 86">
              <a:extLst>
                <a:ext uri="{FF2B5EF4-FFF2-40B4-BE49-F238E27FC236}">
                  <a16:creationId xmlns:a16="http://schemas.microsoft.com/office/drawing/2014/main" id="{2FC267AE-2819-4BA5-BAAE-EEB49F291F35}"/>
                </a:ext>
              </a:extLst>
            </p:cNvPr>
            <p:cNvCxnSpPr>
              <a:cxnSpLocks/>
            </p:cNvCxnSpPr>
            <p:nvPr/>
          </p:nvCxnSpPr>
          <p:spPr>
            <a:xfrm>
              <a:off x="7477985" y="894270"/>
              <a:ext cx="128016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1" name="Straight Connector 90">
              <a:extLst>
                <a:ext uri="{FF2B5EF4-FFF2-40B4-BE49-F238E27FC236}">
                  <a16:creationId xmlns:a16="http://schemas.microsoft.com/office/drawing/2014/main" id="{C6AD1514-38B4-4D21-A467-E8021C6EF366}"/>
                </a:ext>
              </a:extLst>
            </p:cNvPr>
            <p:cNvCxnSpPr>
              <a:cxnSpLocks/>
            </p:cNvCxnSpPr>
            <p:nvPr/>
          </p:nvCxnSpPr>
          <p:spPr>
            <a:xfrm>
              <a:off x="5724150" y="894270"/>
              <a:ext cx="128016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2572962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89</Words>
  <Application>Microsoft Office PowerPoint</Application>
  <PresentationFormat>On-screen Show (4:3)</PresentationFormat>
  <Paragraphs>45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Embedded OLE Servers</vt:lpstr>
      </vt:variant>
      <vt:variant>
        <vt:i4>0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1_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id Sebti</dc:creator>
  <cp:lastModifiedBy>Said Sebti</cp:lastModifiedBy>
  <cp:revision>1</cp:revision>
  <dcterms:created xsi:type="dcterms:W3CDTF">2023-10-30T19:43:56Z</dcterms:created>
  <dcterms:modified xsi:type="dcterms:W3CDTF">2023-10-30T19:44:21Z</dcterms:modified>
</cp:coreProperties>
</file>